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2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9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00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sv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形 4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829733" y="1896897"/>
            <a:ext cx="7484534" cy="253219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51933" y="4641479"/>
            <a:ext cx="7986455" cy="829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. </a:t>
            </a:r>
            <a:r>
              <a:rPr lang="en-US" altLang="zh-CN" sz="12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4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The molecular characteristics and sequencing condition in the paired tumor tissues of plasma samples with different mutation types.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(A) The percentage of tumor cells (A), effective sequencing depth (B), the number of somatic mutations (C) and maximum SAF (D) in the paired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tissues of plasma samples with different mutation types. SAF, somatic allele frequency.</a:t>
            </a:r>
            <a:endParaRPr lang="en-US" altLang="zh-C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adc0015f-a85e-4dcb-974d-f2a826d0cd7e"/>
  <p:tag name="COMMONDATA" val="eyJoZGlkIjoiZjJkNmJiODU1NzA1YWVjNGUwNTk3ZDA3NTIxZGRlMDUifQ==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9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Calibri Light</vt:lpstr>
      <vt:lpstr>等线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eneplus</dc:creator>
  <cp:lastModifiedBy>熊歪歪</cp:lastModifiedBy>
  <cp:revision>44</cp:revision>
  <dcterms:created xsi:type="dcterms:W3CDTF">2022-12-19T12:12:00Z</dcterms:created>
  <dcterms:modified xsi:type="dcterms:W3CDTF">2023-01-29T13:24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74A3FC939243238FFA33F338A39700</vt:lpwstr>
  </property>
  <property fmtid="{D5CDD505-2E9C-101B-9397-08002B2CF9AE}" pid="3" name="KSOProductBuildVer">
    <vt:lpwstr>2052-11.1.0.13703</vt:lpwstr>
  </property>
</Properties>
</file>